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2376" y="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48048-574D-4621-8C0A-356FC3F1FA24}" type="datetimeFigureOut">
              <a:rPr lang="en-GB" smtClean="0"/>
              <a:t>25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E1F7-CE68-4677-B7C8-F952CF32F6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48099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48048-574D-4621-8C0A-356FC3F1FA24}" type="datetimeFigureOut">
              <a:rPr lang="en-GB" smtClean="0"/>
              <a:t>25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E1F7-CE68-4677-B7C8-F952CF32F6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92149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48048-574D-4621-8C0A-356FC3F1FA24}" type="datetimeFigureOut">
              <a:rPr lang="en-GB" smtClean="0"/>
              <a:t>25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E1F7-CE68-4677-B7C8-F952CF32F6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33699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48048-574D-4621-8C0A-356FC3F1FA24}" type="datetimeFigureOut">
              <a:rPr lang="en-GB" smtClean="0"/>
              <a:t>25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E1F7-CE68-4677-B7C8-F952CF32F6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21311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48048-574D-4621-8C0A-356FC3F1FA24}" type="datetimeFigureOut">
              <a:rPr lang="en-GB" smtClean="0"/>
              <a:t>25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E1F7-CE68-4677-B7C8-F952CF32F6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5916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48048-574D-4621-8C0A-356FC3F1FA24}" type="datetimeFigureOut">
              <a:rPr lang="en-GB" smtClean="0"/>
              <a:t>25/09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E1F7-CE68-4677-B7C8-F952CF32F6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24858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48048-574D-4621-8C0A-356FC3F1FA24}" type="datetimeFigureOut">
              <a:rPr lang="en-GB" smtClean="0"/>
              <a:t>25/09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E1F7-CE68-4677-B7C8-F952CF32F6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17301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48048-574D-4621-8C0A-356FC3F1FA24}" type="datetimeFigureOut">
              <a:rPr lang="en-GB" smtClean="0"/>
              <a:t>25/09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E1F7-CE68-4677-B7C8-F952CF32F6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74275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48048-574D-4621-8C0A-356FC3F1FA24}" type="datetimeFigureOut">
              <a:rPr lang="en-GB" smtClean="0"/>
              <a:t>25/09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E1F7-CE68-4677-B7C8-F952CF32F6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39273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48048-574D-4621-8C0A-356FC3F1FA24}" type="datetimeFigureOut">
              <a:rPr lang="en-GB" smtClean="0"/>
              <a:t>25/09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E1F7-CE68-4677-B7C8-F952CF32F6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01637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48048-574D-4621-8C0A-356FC3F1FA24}" type="datetimeFigureOut">
              <a:rPr lang="en-GB" smtClean="0"/>
              <a:t>25/09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E1F7-CE68-4677-B7C8-F952CF32F6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40335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F48048-574D-4621-8C0A-356FC3F1FA24}" type="datetimeFigureOut">
              <a:rPr lang="en-GB" smtClean="0"/>
              <a:t>25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E2E1F7-CE68-4677-B7C8-F952CF32F6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70760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2688" y="846138"/>
            <a:ext cx="4492625" cy="2657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65238" y="3917950"/>
            <a:ext cx="4492625" cy="25844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088669" y="6887998"/>
            <a:ext cx="458664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ld increases relative to GAPDH in expression of cytokines A. IL-17, B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L-22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cosal and lymph node tissue from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leal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leocaecal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lve sites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btained from HAV vaccinated (black) or Sham vaccinated (grey) calves obtained 38 weeks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t challenge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No significance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tween groups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 seen (</a:t>
            </a:r>
            <a:r>
              <a:rPr lang="en-GB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gt; 0.05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97655" y="421651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821171" y="114411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" name="Rectangle 8"/>
          <p:cNvSpPr/>
          <p:nvPr/>
        </p:nvSpPr>
        <p:spPr>
          <a:xfrm>
            <a:off x="1948242" y="696445"/>
            <a:ext cx="3546784" cy="58616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Rectangle 9"/>
          <p:cNvSpPr/>
          <p:nvPr/>
        </p:nvSpPr>
        <p:spPr>
          <a:xfrm>
            <a:off x="2015578" y="3677223"/>
            <a:ext cx="3546784" cy="58616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42281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39</TotalTime>
  <Words>61</Words>
  <Application>Microsoft Office PowerPoint</Application>
  <PresentationFormat>Affichage à l'écran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résentation PowerPoint</vt:lpstr>
    </vt:vector>
  </TitlesOfParts>
  <Company>SGU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m Bull</dc:creator>
  <cp:lastModifiedBy>ecoulamy</cp:lastModifiedBy>
  <cp:revision>155</cp:revision>
  <cp:lastPrinted>2014-03-26T18:13:40Z</cp:lastPrinted>
  <dcterms:created xsi:type="dcterms:W3CDTF">2014-03-24T11:22:18Z</dcterms:created>
  <dcterms:modified xsi:type="dcterms:W3CDTF">2014-09-25T12:50:55Z</dcterms:modified>
</cp:coreProperties>
</file>